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1" r:id="rId2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64" userDrawn="1">
          <p15:clr>
            <a:srgbClr val="A4A3A4"/>
          </p15:clr>
        </p15:guide>
        <p15:guide id="2" pos="42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600FF"/>
    <a:srgbClr val="A5FF6B"/>
    <a:srgbClr val="FF9231"/>
    <a:srgbClr val="EA003F"/>
    <a:srgbClr val="E13AFE"/>
    <a:srgbClr val="DB9700"/>
    <a:srgbClr val="00F2A1"/>
    <a:srgbClr val="00907C"/>
    <a:srgbClr val="4A4FC5"/>
    <a:srgbClr val="E9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95"/>
    <p:restoredTop sz="94694"/>
  </p:normalViewPr>
  <p:slideViewPr>
    <p:cSldViewPr snapToGrid="0" snapToObjects="1">
      <p:cViewPr varScale="1">
        <p:scale>
          <a:sx n="82" d="100"/>
          <a:sy n="82" d="100"/>
        </p:scale>
        <p:origin x="4080" y="192"/>
      </p:cViewPr>
      <p:guideLst>
        <p:guide orient="horz" pos="5064"/>
        <p:guide pos="4224"/>
      </p:guideLst>
    </p:cSldViewPr>
  </p:slideViewPr>
  <p:notesTextViewPr>
    <p:cViewPr>
      <p:scale>
        <a:sx n="85" d="100"/>
        <a:sy n="8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0D109F-9FEC-DA44-A69C-E029EAED4A05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1143000"/>
            <a:ext cx="2244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61CA8D-B548-7247-B2E9-BB70CA9702F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32029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62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4313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355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9613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82108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056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0571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929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22369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958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188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5123D-F290-C341-8654-3BA8AF323E09}" type="datetimeFigureOut">
              <a:rPr lang="en-US" smtClean="0"/>
              <a:t>4/29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6DEE3-3E10-504B-A4A6-7668CE917EF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347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AFA97299-EFBC-5947-B93B-2598CA9E33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1715512"/>
              </p:ext>
            </p:extLst>
          </p:nvPr>
        </p:nvGraphicFramePr>
        <p:xfrm>
          <a:off x="494788" y="2072548"/>
          <a:ext cx="6325623" cy="2453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74035">
                  <a:extLst>
                    <a:ext uri="{9D8B030D-6E8A-4147-A177-3AD203B41FA5}">
                      <a16:colId xmlns:a16="http://schemas.microsoft.com/office/drawing/2014/main" val="2121852144"/>
                    </a:ext>
                  </a:extLst>
                </a:gridCol>
                <a:gridCol w="1074936">
                  <a:extLst>
                    <a:ext uri="{9D8B030D-6E8A-4147-A177-3AD203B41FA5}">
                      <a16:colId xmlns:a16="http://schemas.microsoft.com/office/drawing/2014/main" val="2251496710"/>
                    </a:ext>
                  </a:extLst>
                </a:gridCol>
                <a:gridCol w="1695519">
                  <a:extLst>
                    <a:ext uri="{9D8B030D-6E8A-4147-A177-3AD203B41FA5}">
                      <a16:colId xmlns:a16="http://schemas.microsoft.com/office/drawing/2014/main" val="2785899881"/>
                    </a:ext>
                  </a:extLst>
                </a:gridCol>
                <a:gridCol w="1108183">
                  <a:extLst>
                    <a:ext uri="{9D8B030D-6E8A-4147-A177-3AD203B41FA5}">
                      <a16:colId xmlns:a16="http://schemas.microsoft.com/office/drawing/2014/main" val="2127632051"/>
                    </a:ext>
                  </a:extLst>
                </a:gridCol>
                <a:gridCol w="687073">
                  <a:extLst>
                    <a:ext uri="{9D8B030D-6E8A-4147-A177-3AD203B41FA5}">
                      <a16:colId xmlns:a16="http://schemas.microsoft.com/office/drawing/2014/main" val="3775949488"/>
                    </a:ext>
                  </a:extLst>
                </a:gridCol>
                <a:gridCol w="985877">
                  <a:extLst>
                    <a:ext uri="{9D8B030D-6E8A-4147-A177-3AD203B41FA5}">
                      <a16:colId xmlns:a16="http://schemas.microsoft.com/office/drawing/2014/main" val="1723575505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pPr marL="0" marR="0" lvl="0" indent="0" algn="l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1</a:t>
                      </a:r>
                      <a:r>
                        <a:rPr lang="en-US" sz="1100" b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 Marker characteristics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69114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bes I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SC </a:t>
                      </a:r>
                      <a:r>
                        <a:rPr lang="en-US" sz="9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Gene</a:t>
                      </a: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am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SC </a:t>
                      </a:r>
                      <a:r>
                        <a:rPr lang="en-US" sz="9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Gene</a:t>
                      </a: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cessio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SC </a:t>
                      </a:r>
                      <a:r>
                        <a:rPr lang="en-US" sz="9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Gene</a:t>
                      </a: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hancer</a:t>
                      </a:r>
                      <a:endParaRPr 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ation to Islan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1649978"/>
                  </a:ext>
                </a:extLst>
              </a:tr>
              <a:tr h="1470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1908954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3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1165257;NM_013243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UTR;1stExo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lan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8831648"/>
                  </a:ext>
                </a:extLst>
              </a:tr>
              <a:tr h="15928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3242819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CK1;FAM196A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1380;NM_00103976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;TSS200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lan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7278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4640109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FPM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1208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S1500</a:t>
                      </a:r>
                      <a:endParaRPr 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_Shor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74635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5491001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lan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3908374"/>
                  </a:ext>
                </a:extLst>
              </a:tr>
              <a:tr h="1470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07950000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K1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0830;NM_175611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S200;TSS200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u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_Shor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7689330"/>
                  </a:ext>
                </a:extLst>
              </a:tr>
              <a:tr h="1470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14781189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H7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173162;NM_03327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stExon;5'UTR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enSea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7784741"/>
                  </a:ext>
                </a:extLst>
              </a:tr>
              <a:tr h="1470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15085899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OR2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_006312;NM_001077261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73152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UTR;5'UTR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u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lan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27614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25567674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se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lan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42879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88976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77</TotalTime>
  <Words>110</Words>
  <Application>Microsoft Macintosh PowerPoint</Application>
  <PresentationFormat>Custom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adley Downs</dc:creator>
  <cp:lastModifiedBy>Bradley Downs</cp:lastModifiedBy>
  <cp:revision>449</cp:revision>
  <cp:lastPrinted>2021-03-15T15:34:39Z</cp:lastPrinted>
  <dcterms:created xsi:type="dcterms:W3CDTF">2019-09-14T17:51:09Z</dcterms:created>
  <dcterms:modified xsi:type="dcterms:W3CDTF">2021-04-29T16:22:03Z</dcterms:modified>
</cp:coreProperties>
</file>